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-1008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5F8A4-8855-40CD-ACAF-4A804DEBD569}" type="datetimeFigureOut">
              <a:rPr lang="zh-CN" altLang="en-US" smtClean="0"/>
              <a:t>2015-06-0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2715A-281E-4E7A-AAFE-0F0F62814E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24786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5F8A4-8855-40CD-ACAF-4A804DEBD569}" type="datetimeFigureOut">
              <a:rPr lang="zh-CN" altLang="en-US" smtClean="0"/>
              <a:t>2015-06-0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2715A-281E-4E7A-AAFE-0F0F62814E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94258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5F8A4-8855-40CD-ACAF-4A804DEBD569}" type="datetimeFigureOut">
              <a:rPr lang="zh-CN" altLang="en-US" smtClean="0"/>
              <a:t>2015-06-0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2715A-281E-4E7A-AAFE-0F0F62814E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83563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5F8A4-8855-40CD-ACAF-4A804DEBD569}" type="datetimeFigureOut">
              <a:rPr lang="zh-CN" altLang="en-US" smtClean="0"/>
              <a:t>2015-06-0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2715A-281E-4E7A-AAFE-0F0F62814E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715715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5F8A4-8855-40CD-ACAF-4A804DEBD569}" type="datetimeFigureOut">
              <a:rPr lang="zh-CN" altLang="en-US" smtClean="0"/>
              <a:t>2015-06-0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2715A-281E-4E7A-AAFE-0F0F62814E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92815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5F8A4-8855-40CD-ACAF-4A804DEBD569}" type="datetimeFigureOut">
              <a:rPr lang="zh-CN" altLang="en-US" smtClean="0"/>
              <a:t>2015-06-0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2715A-281E-4E7A-AAFE-0F0F62814E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85773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5F8A4-8855-40CD-ACAF-4A804DEBD569}" type="datetimeFigureOut">
              <a:rPr lang="zh-CN" altLang="en-US" smtClean="0"/>
              <a:t>2015-06-0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2715A-281E-4E7A-AAFE-0F0F62814E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81195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5F8A4-8855-40CD-ACAF-4A804DEBD569}" type="datetimeFigureOut">
              <a:rPr lang="zh-CN" altLang="en-US" smtClean="0"/>
              <a:t>2015-06-0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2715A-281E-4E7A-AAFE-0F0F62814E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41314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5F8A4-8855-40CD-ACAF-4A804DEBD569}" type="datetimeFigureOut">
              <a:rPr lang="zh-CN" altLang="en-US" smtClean="0"/>
              <a:t>2015-06-0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2715A-281E-4E7A-AAFE-0F0F62814E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9545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5F8A4-8855-40CD-ACAF-4A804DEBD569}" type="datetimeFigureOut">
              <a:rPr lang="zh-CN" altLang="en-US" smtClean="0"/>
              <a:t>2015-06-0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2715A-281E-4E7A-AAFE-0F0F62814E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8881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5F8A4-8855-40CD-ACAF-4A804DEBD569}" type="datetimeFigureOut">
              <a:rPr lang="zh-CN" altLang="en-US" smtClean="0"/>
              <a:t>2015-06-0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62715A-281E-4E7A-AAFE-0F0F62814E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56881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C5F8A4-8855-40CD-ACAF-4A804DEBD569}" type="datetimeFigureOut">
              <a:rPr lang="zh-CN" altLang="en-US" smtClean="0"/>
              <a:t>2015-06-0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62715A-281E-4E7A-AAFE-0F0F62814E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9934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604649" y="-73987"/>
            <a:ext cx="806489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/>
              <a:t>Figure S3 Amino acid sequence alignment of melon </a:t>
            </a:r>
            <a:r>
              <a:rPr lang="en-US" altLang="zh-CN" b="1" i="1" dirty="0"/>
              <a:t>CmFDH1</a:t>
            </a:r>
            <a:r>
              <a:rPr lang="en-US" altLang="zh-CN" b="1" dirty="0"/>
              <a:t> (MELO3C022399P1) with closely related sequences of other plants. </a:t>
            </a:r>
            <a:endParaRPr lang="zh-CN" altLang="en-US" dirty="0"/>
          </a:p>
        </p:txBody>
      </p:sp>
      <p:sp>
        <p:nvSpPr>
          <p:cNvPr id="5" name="Rectangle 24"/>
          <p:cNvSpPr>
            <a:spLocks noChangeArrowheads="1"/>
          </p:cNvSpPr>
          <p:nvPr/>
        </p:nvSpPr>
        <p:spPr bwMode="auto">
          <a:xfrm>
            <a:off x="152400" y="1524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pic>
        <p:nvPicPr>
          <p:cNvPr id="30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76256" y="6397174"/>
            <a:ext cx="2146770" cy="4608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1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0732" y="476672"/>
            <a:ext cx="7543924" cy="29519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2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0732" y="3446031"/>
            <a:ext cx="7543924" cy="29519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3" name="矩形 32"/>
          <p:cNvSpPr/>
          <p:nvPr/>
        </p:nvSpPr>
        <p:spPr>
          <a:xfrm>
            <a:off x="5364088" y="548680"/>
            <a:ext cx="432048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zh-CN" altLang="zh-CN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rPr>
              <a:t>▽</a:t>
            </a:r>
            <a:endParaRPr kumimoji="0" lang="zh-CN" altLang="zh-CN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34" name="矩形 33"/>
          <p:cNvSpPr/>
          <p:nvPr/>
        </p:nvSpPr>
        <p:spPr>
          <a:xfrm>
            <a:off x="7092280" y="548680"/>
            <a:ext cx="390534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zh-CN" altLang="zh-CN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rPr>
              <a:t>▽</a:t>
            </a:r>
            <a:endParaRPr kumimoji="0" lang="zh-CN" altLang="zh-CN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35" name="矩形 34"/>
          <p:cNvSpPr/>
          <p:nvPr/>
        </p:nvSpPr>
        <p:spPr>
          <a:xfrm>
            <a:off x="7195556" y="548680"/>
            <a:ext cx="400780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zh-CN" altLang="zh-CN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rPr>
              <a:t>▽</a:t>
            </a:r>
            <a:endParaRPr kumimoji="0" lang="zh-CN" altLang="zh-CN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36" name="Rectangle 19"/>
          <p:cNvSpPr>
            <a:spLocks noChangeArrowheads="1"/>
          </p:cNvSpPr>
          <p:nvPr/>
        </p:nvSpPr>
        <p:spPr bwMode="auto">
          <a:xfrm>
            <a:off x="7190212" y="548680"/>
            <a:ext cx="1059540" cy="1403977"/>
          </a:xfrm>
          <a:prstGeom prst="rect">
            <a:avLst/>
          </a:prstGeom>
          <a:noFill/>
          <a:ln w="28575">
            <a:solidFill>
              <a:srgbClr val="FF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37" name="Text Box 13"/>
          <p:cNvSpPr txBox="1">
            <a:spLocks noChangeArrowheads="1"/>
          </p:cNvSpPr>
          <p:nvPr/>
        </p:nvSpPr>
        <p:spPr bwMode="auto">
          <a:xfrm>
            <a:off x="7070425" y="1964275"/>
            <a:ext cx="1479503" cy="209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54864" tIns="27432" rIns="54864" bIns="27432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Zn1 binding motif</a:t>
            </a:r>
            <a:endParaRPr kumimoji="0" lang="en-US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38" name="Rectangle 18"/>
          <p:cNvSpPr>
            <a:spLocks noChangeArrowheads="1"/>
          </p:cNvSpPr>
          <p:nvPr/>
        </p:nvSpPr>
        <p:spPr bwMode="auto">
          <a:xfrm>
            <a:off x="1619672" y="2062868"/>
            <a:ext cx="504056" cy="1383163"/>
          </a:xfrm>
          <a:prstGeom prst="rect">
            <a:avLst/>
          </a:prstGeom>
          <a:noFill/>
          <a:ln w="28575">
            <a:solidFill>
              <a:srgbClr val="FF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39" name="Text Box 13"/>
          <p:cNvSpPr txBox="1">
            <a:spLocks noChangeArrowheads="1"/>
          </p:cNvSpPr>
          <p:nvPr/>
        </p:nvSpPr>
        <p:spPr bwMode="auto">
          <a:xfrm>
            <a:off x="1447179" y="3447479"/>
            <a:ext cx="1353098" cy="209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54864" tIns="27432" rIns="54864" bIns="27432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Zn1 binding motif</a:t>
            </a:r>
            <a:endParaRPr kumimoji="0" lang="en-US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40" name="Rectangle 17"/>
          <p:cNvSpPr>
            <a:spLocks noChangeArrowheads="1"/>
          </p:cNvSpPr>
          <p:nvPr/>
        </p:nvSpPr>
        <p:spPr bwMode="auto">
          <a:xfrm>
            <a:off x="2537796" y="2062868"/>
            <a:ext cx="2204898" cy="1384611"/>
          </a:xfrm>
          <a:prstGeom prst="rect">
            <a:avLst/>
          </a:prstGeom>
          <a:noFill/>
          <a:ln w="28575">
            <a:solidFill>
              <a:srgbClr val="FF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41" name="Rectangle 10"/>
          <p:cNvSpPr>
            <a:spLocks noChangeArrowheads="1"/>
          </p:cNvSpPr>
          <p:nvPr/>
        </p:nvSpPr>
        <p:spPr bwMode="auto">
          <a:xfrm>
            <a:off x="3645558" y="2082851"/>
            <a:ext cx="211193" cy="1817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42793" tIns="21397" rIns="42793" bIns="21397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rPr>
              <a:t>▼</a:t>
            </a:r>
            <a:endParaRPr kumimoji="0" lang="zh-CN" altLang="zh-CN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42" name="Rectangle 10"/>
          <p:cNvSpPr>
            <a:spLocks noChangeArrowheads="1"/>
          </p:cNvSpPr>
          <p:nvPr/>
        </p:nvSpPr>
        <p:spPr bwMode="auto">
          <a:xfrm>
            <a:off x="3864796" y="2085313"/>
            <a:ext cx="211193" cy="1817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42793" tIns="21397" rIns="42793" bIns="21397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rPr>
              <a:t>▼</a:t>
            </a:r>
            <a:endParaRPr kumimoji="0" lang="zh-CN" altLang="zh-CN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43" name="Rectangle 10"/>
          <p:cNvSpPr>
            <a:spLocks noChangeArrowheads="1"/>
          </p:cNvSpPr>
          <p:nvPr/>
        </p:nvSpPr>
        <p:spPr bwMode="auto">
          <a:xfrm>
            <a:off x="4531501" y="2062868"/>
            <a:ext cx="211193" cy="1817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42793" tIns="21397" rIns="42793" bIns="21397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rPr>
              <a:t>▼</a:t>
            </a:r>
            <a:endParaRPr kumimoji="0" lang="zh-CN" altLang="zh-CN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44" name="Rectangle 10"/>
          <p:cNvSpPr>
            <a:spLocks noChangeArrowheads="1"/>
          </p:cNvSpPr>
          <p:nvPr/>
        </p:nvSpPr>
        <p:spPr bwMode="auto">
          <a:xfrm>
            <a:off x="3342928" y="2085313"/>
            <a:ext cx="211193" cy="1817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42793" tIns="21397" rIns="42793" bIns="21397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rPr>
              <a:t>▼</a:t>
            </a:r>
            <a:endParaRPr kumimoji="0" lang="zh-CN" altLang="zh-CN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45" name="Text Box 14"/>
          <p:cNvSpPr txBox="1">
            <a:spLocks noChangeArrowheads="1"/>
          </p:cNvSpPr>
          <p:nvPr/>
        </p:nvSpPr>
        <p:spPr bwMode="auto">
          <a:xfrm>
            <a:off x="2890455" y="3459580"/>
            <a:ext cx="1932591" cy="209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54864" tIns="27432" rIns="54864" bIns="27432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Zn2 binding motif</a:t>
            </a:r>
            <a:endParaRPr kumimoji="0" lang="en-US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46" name="Rectangle 16"/>
          <p:cNvSpPr>
            <a:spLocks noChangeArrowheads="1"/>
          </p:cNvSpPr>
          <p:nvPr/>
        </p:nvSpPr>
        <p:spPr bwMode="auto">
          <a:xfrm>
            <a:off x="5546738" y="3552123"/>
            <a:ext cx="609438" cy="1369893"/>
          </a:xfrm>
          <a:prstGeom prst="rect">
            <a:avLst/>
          </a:prstGeom>
          <a:noFill/>
          <a:ln w="28575">
            <a:solidFill>
              <a:srgbClr val="FF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47" name="Rectangle 3"/>
          <p:cNvSpPr>
            <a:spLocks noChangeArrowheads="1"/>
          </p:cNvSpPr>
          <p:nvPr/>
        </p:nvSpPr>
        <p:spPr bwMode="auto">
          <a:xfrm>
            <a:off x="5476804" y="3551991"/>
            <a:ext cx="139867" cy="164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41148" tIns="20574" rIns="41148" bIns="20574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rPr>
              <a:t>●</a:t>
            </a:r>
            <a:endParaRPr kumimoji="0" lang="zh-CN" altLang="zh-CN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48" name="Rectangle 3"/>
          <p:cNvSpPr>
            <a:spLocks noChangeArrowheads="1"/>
          </p:cNvSpPr>
          <p:nvPr/>
        </p:nvSpPr>
        <p:spPr bwMode="auto">
          <a:xfrm>
            <a:off x="5656269" y="3564224"/>
            <a:ext cx="195188" cy="164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41148" tIns="20574" rIns="41148" bIns="20574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rPr>
              <a:t>●</a:t>
            </a:r>
            <a:endParaRPr kumimoji="0" lang="zh-CN" altLang="zh-CN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49" name="Rectangle 3"/>
          <p:cNvSpPr>
            <a:spLocks noChangeArrowheads="1"/>
          </p:cNvSpPr>
          <p:nvPr/>
        </p:nvSpPr>
        <p:spPr bwMode="auto">
          <a:xfrm>
            <a:off x="5895008" y="3564224"/>
            <a:ext cx="195188" cy="1646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41148" tIns="20574" rIns="41148" bIns="20574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rPr>
              <a:t>●</a:t>
            </a:r>
            <a:endParaRPr kumimoji="0" lang="zh-CN" altLang="zh-CN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50" name="Text Box 15"/>
          <p:cNvSpPr txBox="1">
            <a:spLocks noChangeArrowheads="1"/>
          </p:cNvSpPr>
          <p:nvPr/>
        </p:nvSpPr>
        <p:spPr bwMode="auto">
          <a:xfrm>
            <a:off x="5312180" y="4922016"/>
            <a:ext cx="2244258" cy="209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BBE0E3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54864" tIns="27432" rIns="54864" bIns="27432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NADPH binding motif</a:t>
            </a:r>
            <a:endParaRPr kumimoji="0" lang="en-US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37325308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42</Words>
  <Application>Microsoft Office PowerPoint</Application>
  <PresentationFormat>全屏显示(4:3)</PresentationFormat>
  <Paragraphs>15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Company>Lenov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C SYSTEM</dc:creator>
  <cp:lastModifiedBy>MC SYSTEM</cp:lastModifiedBy>
  <cp:revision>3</cp:revision>
  <dcterms:created xsi:type="dcterms:W3CDTF">2015-04-21T06:20:31Z</dcterms:created>
  <dcterms:modified xsi:type="dcterms:W3CDTF">2015-06-07T08:47:53Z</dcterms:modified>
</cp:coreProperties>
</file>